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4A9D1-7C5A-4649-8F5A-4396EB126D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60CDE5-33A4-4607-91E4-A4E4FC36FA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6C015-1087-4EA6-984F-7A221AFC1A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A69285-C327-4CEE-9E10-430A4D5AEA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4B2516-1226-4077-9156-DA82F84055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19B94-0AB0-46C6-9BD4-8B7551C665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50E2C5-F772-4ECD-9130-288DDD97E1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535056-B738-499D-9B33-8FE51ABF6F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855991-8093-4713-8529-994BA51351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50992-545C-414D-ADB6-27AB591B1C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11849C-779F-49D9-B00B-768DC21AB2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E065F-B8B9-442C-B3F1-337E882CC3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24F69C-A8D1-4A09-8B15-195172DE639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84360" y="5445000"/>
            <a:ext cx="77040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Figure S1.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Alignment of deduced amino acid substitutions in the variant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ORF .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Putative CPE amino acid substitutions encoded by strains PB-1 were highly homologous with the previously known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gene, especially in the receptor binding region and the major cytotoxicity region. Different amino acid substitutions are indicated as a bold letter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826920" y="333360"/>
            <a:ext cx="7410600" cy="4924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4T00:01:52Z</dcterms:created>
  <dc:creator>MIYAMOTO</dc:creator>
  <dc:description/>
  <dc:language>en-US</dc:language>
  <cp:lastModifiedBy>MIYAMOTO</cp:lastModifiedBy>
  <dcterms:modified xsi:type="dcterms:W3CDTF">2011-05-04T00:02:02Z</dcterms:modified>
  <cp:revision>1</cp:revision>
  <dc:subject/>
  <dc:title>スライド 1</dc:title>
</cp:coreProperties>
</file>